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5"/>
    <p:restoredTop sz="94633"/>
  </p:normalViewPr>
  <p:slideViewPr>
    <p:cSldViewPr snapToGrid="0" snapToObjects="1" showGuides="1">
      <p:cViewPr varScale="1">
        <p:scale>
          <a:sx n="212" d="100"/>
          <a:sy n="212" d="100"/>
        </p:scale>
        <p:origin x="25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クリックして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F61B62F9-8EF5-4A40-BD31-CB6FFF648EE5}"/>
              </a:ext>
            </a:extLst>
          </p:cNvPr>
          <p:cNvCxnSpPr>
            <a:cxnSpLocks/>
          </p:cNvCxnSpPr>
          <p:nvPr/>
        </p:nvCxnSpPr>
        <p:spPr>
          <a:xfrm flipH="1">
            <a:off x="3823226" y="898194"/>
            <a:ext cx="1" cy="208485"/>
          </a:xfrm>
          <a:prstGeom prst="line">
            <a:avLst/>
          </a:prstGeom>
          <a:ln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>
            <a:cxnSpLocks/>
          </p:cNvCxnSpPr>
          <p:nvPr/>
        </p:nvCxnSpPr>
        <p:spPr>
          <a:xfrm>
            <a:off x="6017482" y="918467"/>
            <a:ext cx="0" cy="1070706"/>
          </a:xfrm>
          <a:prstGeom prst="line">
            <a:avLst/>
          </a:prstGeom>
          <a:ln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35"/>
          <p:cNvSpPr/>
          <p:nvPr/>
        </p:nvSpPr>
        <p:spPr>
          <a:xfrm>
            <a:off x="611027" y="5650567"/>
            <a:ext cx="726440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ea typeface="Times New Roman" charset="0"/>
                <a:cs typeface="Times New Roman" panose="02020603050405020304" pitchFamily="18" charset="0"/>
              </a:rPr>
              <a:t>S2 Fig.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chart of the sRNA data  processing and the miRNA candidates detection.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759588" y="1380907"/>
            <a:ext cx="2515789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tering by normalized counts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614177" y="577582"/>
            <a:ext cx="1184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reads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8ED3C1E8-72C0-F74E-9B15-B55606EEE9DE}"/>
              </a:ext>
            </a:extLst>
          </p:cNvPr>
          <p:cNvGrpSpPr/>
          <p:nvPr/>
        </p:nvGrpSpPr>
        <p:grpSpPr>
          <a:xfrm>
            <a:off x="5007962" y="634084"/>
            <a:ext cx="2019041" cy="390845"/>
            <a:chOff x="1377580" y="2630284"/>
            <a:chExt cx="2019041" cy="390845"/>
          </a:xfrm>
        </p:grpSpPr>
        <p:sp>
          <p:nvSpPr>
            <p:cNvPr id="18" name="円/楕円 17">
              <a:extLst>
                <a:ext uri="{FF2B5EF4-FFF2-40B4-BE49-F238E27FC236}">
                  <a16:creationId xmlns:a16="http://schemas.microsoft.com/office/drawing/2014/main" id="{9575023C-04F6-ED4F-96C0-BDA412871281}"/>
                </a:ext>
              </a:extLst>
            </p:cNvPr>
            <p:cNvSpPr/>
            <p:nvPr/>
          </p:nvSpPr>
          <p:spPr>
            <a:xfrm>
              <a:off x="1377580" y="2630284"/>
              <a:ext cx="2019041" cy="390845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422184" y="2637688"/>
              <a:ext cx="1925219" cy="376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ique </a:t>
              </a:r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es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7" name="円/楕円 56">
            <a:extLst>
              <a:ext uri="{FF2B5EF4-FFF2-40B4-BE49-F238E27FC236}">
                <a16:creationId xmlns:a16="http://schemas.microsoft.com/office/drawing/2014/main" id="{11B560A1-DD72-024E-913E-E3AC438E61E9}"/>
              </a:ext>
            </a:extLst>
          </p:cNvPr>
          <p:cNvSpPr/>
          <p:nvPr/>
        </p:nvSpPr>
        <p:spPr>
          <a:xfrm>
            <a:off x="5031062" y="4867759"/>
            <a:ext cx="2019041" cy="390845"/>
          </a:xfrm>
          <a:prstGeom prst="ellipse">
            <a:avLst/>
          </a:prstGeom>
          <a:noFill/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E2300B19-B8AC-794C-AE88-776372706B11}"/>
              </a:ext>
            </a:extLst>
          </p:cNvPr>
          <p:cNvSpPr/>
          <p:nvPr/>
        </p:nvSpPr>
        <p:spPr>
          <a:xfrm>
            <a:off x="5070725" y="4864643"/>
            <a:ext cx="19223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NA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s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3078484" y="608360"/>
            <a:ext cx="1362267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y control</a:t>
            </a:r>
          </a:p>
        </p:txBody>
      </p:sp>
      <p:sp>
        <p:nvSpPr>
          <p:cNvPr id="3" name="円/楕円 2">
            <a:extLst>
              <a:ext uri="{FF2B5EF4-FFF2-40B4-BE49-F238E27FC236}">
                <a16:creationId xmlns:a16="http://schemas.microsoft.com/office/drawing/2014/main" id="{B020AF9E-E20B-CC42-A4CA-B252E3EC589C}"/>
              </a:ext>
            </a:extLst>
          </p:cNvPr>
          <p:cNvSpPr/>
          <p:nvPr/>
        </p:nvSpPr>
        <p:spPr>
          <a:xfrm>
            <a:off x="1577821" y="564018"/>
            <a:ext cx="1173079" cy="396460"/>
          </a:xfrm>
          <a:prstGeom prst="ellipse">
            <a:avLst/>
          </a:prstGeom>
          <a:noFill/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8548B372-C3BC-424B-9DED-F073DCB300A1}"/>
              </a:ext>
            </a:extLst>
          </p:cNvPr>
          <p:cNvSpPr/>
          <p:nvPr/>
        </p:nvSpPr>
        <p:spPr>
          <a:xfrm>
            <a:off x="3078484" y="1093325"/>
            <a:ext cx="1542474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marL="276225" indent="-276225" algn="ctr">
              <a:tabLst>
                <a:tab pos="127000" algn="l"/>
              </a:tabLst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ndancy check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AF37E35C-FF7F-DB48-A552-A258A9E5CEED}"/>
              </a:ext>
            </a:extLst>
          </p:cNvPr>
          <p:cNvCxnSpPr>
            <a:cxnSpLocks/>
            <a:stCxn id="3" idx="6"/>
            <a:endCxn id="25" idx="1"/>
          </p:cNvCxnSpPr>
          <p:nvPr/>
        </p:nvCxnSpPr>
        <p:spPr>
          <a:xfrm>
            <a:off x="2750900" y="762248"/>
            <a:ext cx="327584" cy="1"/>
          </a:xfrm>
          <a:prstGeom prst="line">
            <a:avLst/>
          </a:prstGeom>
          <a:ln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11A74A06-9D52-404E-93D6-A43BC6379832}"/>
              </a:ext>
            </a:extLst>
          </p:cNvPr>
          <p:cNvCxnSpPr>
            <a:cxnSpLocks/>
          </p:cNvCxnSpPr>
          <p:nvPr/>
        </p:nvCxnSpPr>
        <p:spPr>
          <a:xfrm flipV="1">
            <a:off x="4620958" y="834900"/>
            <a:ext cx="387004" cy="367307"/>
          </a:xfrm>
          <a:prstGeom prst="line">
            <a:avLst/>
          </a:prstGeom>
          <a:ln>
            <a:solidFill>
              <a:schemeClr val="tx1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3CCBF05D-9FA0-144E-B3EF-C8436C3ADDDB}"/>
              </a:ext>
            </a:extLst>
          </p:cNvPr>
          <p:cNvCxnSpPr>
            <a:cxnSpLocks/>
          </p:cNvCxnSpPr>
          <p:nvPr/>
        </p:nvCxnSpPr>
        <p:spPr>
          <a:xfrm>
            <a:off x="5300058" y="2323070"/>
            <a:ext cx="0" cy="1682962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2C03C294-74FA-4F40-966A-97E54CB0EB9C}"/>
              </a:ext>
            </a:extLst>
          </p:cNvPr>
          <p:cNvCxnSpPr>
            <a:cxnSpLocks/>
          </p:cNvCxnSpPr>
          <p:nvPr/>
        </p:nvCxnSpPr>
        <p:spPr>
          <a:xfrm flipH="1">
            <a:off x="6725677" y="2290190"/>
            <a:ext cx="1" cy="1715842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CD01391-99B8-384F-986A-0F86709F8826}"/>
              </a:ext>
            </a:extLst>
          </p:cNvPr>
          <p:cNvGrpSpPr/>
          <p:nvPr/>
        </p:nvGrpSpPr>
        <p:grpSpPr>
          <a:xfrm>
            <a:off x="5295230" y="4011503"/>
            <a:ext cx="1440138" cy="837206"/>
            <a:chOff x="5396830" y="4024203"/>
            <a:chExt cx="1440138" cy="837206"/>
          </a:xfrm>
        </p:grpSpPr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4E08AEC4-9A6C-4A48-B20A-F0EBB16869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18250" y="4025736"/>
              <a:ext cx="718718" cy="27502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C576CCFC-67A2-9847-8830-3B0A30A2521F}"/>
                </a:ext>
              </a:extLst>
            </p:cNvPr>
            <p:cNvCxnSpPr>
              <a:cxnSpLocks/>
            </p:cNvCxnSpPr>
            <p:nvPr/>
          </p:nvCxnSpPr>
          <p:spPr>
            <a:xfrm>
              <a:off x="6118250" y="4288062"/>
              <a:ext cx="11233" cy="573347"/>
            </a:xfrm>
            <a:prstGeom prst="line">
              <a:avLst/>
            </a:prstGeom>
            <a:ln>
              <a:solidFill>
                <a:schemeClr val="tx1"/>
              </a:solidFill>
              <a:tailEnd type="stealt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F72C93F2-1251-F24A-B1E4-5623C420FAE8}"/>
                </a:ext>
              </a:extLst>
            </p:cNvPr>
            <p:cNvCxnSpPr>
              <a:cxnSpLocks/>
            </p:cNvCxnSpPr>
            <p:nvPr/>
          </p:nvCxnSpPr>
          <p:spPr>
            <a:xfrm>
              <a:off x="5396830" y="4024203"/>
              <a:ext cx="718718" cy="275028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CCFBDCE-A608-8546-B9F2-E9BAF9AEB2E6}"/>
              </a:ext>
            </a:extLst>
          </p:cNvPr>
          <p:cNvSpPr/>
          <p:nvPr/>
        </p:nvSpPr>
        <p:spPr>
          <a:xfrm>
            <a:off x="5018911" y="3499084"/>
            <a:ext cx="1997142" cy="30777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NA detection</a:t>
            </a: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EB4698D8-A770-7A48-826D-4E1A27FF3579}"/>
              </a:ext>
            </a:extLst>
          </p:cNvPr>
          <p:cNvSpPr/>
          <p:nvPr/>
        </p:nvSpPr>
        <p:spPr>
          <a:xfrm>
            <a:off x="5243430" y="4401997"/>
            <a:ext cx="1542474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marL="276225" indent="-276225">
              <a:tabLst>
                <a:tab pos="127000" algn="l"/>
              </a:tabLst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ndancy check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DA54794F-AA36-6D42-B35B-F7285F8B6AFF}"/>
              </a:ext>
            </a:extLst>
          </p:cNvPr>
          <p:cNvGrpSpPr/>
          <p:nvPr/>
        </p:nvGrpSpPr>
        <p:grpSpPr>
          <a:xfrm>
            <a:off x="3341675" y="2664780"/>
            <a:ext cx="5310695" cy="523220"/>
            <a:chOff x="3290875" y="2664780"/>
            <a:chExt cx="5310695" cy="523220"/>
          </a:xfrm>
        </p:grpSpPr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9825275-942F-8A4B-A4F2-5C1FB7D15AE5}"/>
                </a:ext>
              </a:extLst>
            </p:cNvPr>
            <p:cNvSpPr txBox="1"/>
            <p:nvPr/>
          </p:nvSpPr>
          <p:spPr>
            <a:xfrm>
              <a:off x="6261570" y="2772502"/>
              <a:ext cx="2340000" cy="30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ping to </a:t>
              </a:r>
              <a:r>
                <a:rPr lang="en-US" altLang="ja-JP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cDNAs</a:t>
              </a:r>
              <a:endPara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84C0D775-90A9-E140-A65F-5127EF7B2C1E}"/>
                </a:ext>
              </a:extLst>
            </p:cNvPr>
            <p:cNvSpPr/>
            <p:nvPr/>
          </p:nvSpPr>
          <p:spPr>
            <a:xfrm>
              <a:off x="3290875" y="2664780"/>
              <a:ext cx="2340000" cy="5232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pping to tentative </a:t>
              </a:r>
              <a:r>
                <a:rPr lang="en-US" altLang="ja-JP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igs</a:t>
              </a:r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erived from male strobili</a:t>
              </a: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A07C14E9-0328-F946-8BD6-8E082B3E8A5F}"/>
              </a:ext>
            </a:extLst>
          </p:cNvPr>
          <p:cNvGrpSpPr/>
          <p:nvPr/>
        </p:nvGrpSpPr>
        <p:grpSpPr>
          <a:xfrm>
            <a:off x="5007962" y="1989173"/>
            <a:ext cx="2019041" cy="390845"/>
            <a:chOff x="1377580" y="3820608"/>
            <a:chExt cx="2019041" cy="390845"/>
          </a:xfrm>
        </p:grpSpPr>
        <p:sp>
          <p:nvSpPr>
            <p:cNvPr id="19" name="円/楕円 18">
              <a:extLst>
                <a:ext uri="{FF2B5EF4-FFF2-40B4-BE49-F238E27FC236}">
                  <a16:creationId xmlns:a16="http://schemas.microsoft.com/office/drawing/2014/main" id="{19393788-49CD-9B44-B8E5-6E7D06CD3E14}"/>
                </a:ext>
              </a:extLst>
            </p:cNvPr>
            <p:cNvSpPr/>
            <p:nvPr/>
          </p:nvSpPr>
          <p:spPr>
            <a:xfrm>
              <a:off x="1377580" y="3820608"/>
              <a:ext cx="2019041" cy="390845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508307" y="3831364"/>
              <a:ext cx="1757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tained</a:t>
              </a:r>
              <a:r>
                <a:rPr kumimoji="1"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RNAs</a:t>
              </a:r>
              <a:endParaRPr kumimoji="1"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31777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0</TotalTime>
  <Words>46</Words>
  <Application>Microsoft Macintosh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2</cp:revision>
  <dcterms:created xsi:type="dcterms:W3CDTF">2018-02-23T05:08:34Z</dcterms:created>
  <dcterms:modified xsi:type="dcterms:W3CDTF">2018-02-23T07:28:12Z</dcterms:modified>
</cp:coreProperties>
</file>